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67" d="100"/>
          <a:sy n="67" d="100"/>
        </p:scale>
        <p:origin x="644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Wei Zhang" userId="41ef807c-2e5a-4a32-98b0-f17bd2b1f2a1" providerId="ADAL" clId="{0F3E146E-F2EF-4BB7-930F-935894E19CCE}"/>
    <pc:docChg chg="custSel modSld">
      <pc:chgData name="Wei Zhang" userId="41ef807c-2e5a-4a32-98b0-f17bd2b1f2a1" providerId="ADAL" clId="{0F3E146E-F2EF-4BB7-930F-935894E19CCE}" dt="2022-10-10T10:46:35.613" v="11" actId="1076"/>
      <pc:docMkLst>
        <pc:docMk/>
      </pc:docMkLst>
      <pc:sldChg chg="addSp modSp mod">
        <pc:chgData name="Wei Zhang" userId="41ef807c-2e5a-4a32-98b0-f17bd2b1f2a1" providerId="ADAL" clId="{0F3E146E-F2EF-4BB7-930F-935894E19CCE}" dt="2022-10-10T10:46:35.613" v="11" actId="1076"/>
        <pc:sldMkLst>
          <pc:docMk/>
          <pc:sldMk cId="1927243686" sldId="263"/>
        </pc:sldMkLst>
        <pc:spChg chg="add mod">
          <ac:chgData name="Wei Zhang" userId="41ef807c-2e5a-4a32-98b0-f17bd2b1f2a1" providerId="ADAL" clId="{0F3E146E-F2EF-4BB7-930F-935894E19CCE}" dt="2022-10-10T10:46:35.613" v="11" actId="1076"/>
          <ac:spMkLst>
            <pc:docMk/>
            <pc:sldMk cId="1927243686" sldId="263"/>
            <ac:spMk id="4" creationId="{CD5F0DC7-8537-CBC2-4EE8-8C4035CD561C}"/>
          </ac:spMkLst>
        </pc:spChg>
        <pc:picChg chg="mod">
          <ac:chgData name="Wei Zhang" userId="41ef807c-2e5a-4a32-98b0-f17bd2b1f2a1" providerId="ADAL" clId="{0F3E146E-F2EF-4BB7-930F-935894E19CCE}" dt="2022-10-10T10:46:12.362" v="3" actId="1076"/>
          <ac:picMkLst>
            <pc:docMk/>
            <pc:sldMk cId="1927243686" sldId="263"/>
            <ac:picMk id="2" creationId="{A3560008-B184-49FE-AC51-44EB5C3C51F1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5646B9-DF64-ABB3-5E0B-3573B14A3AC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29207E3-6E0E-163B-A734-698B46E9A9B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NZ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5E21188-6527-80C3-6031-A91624569F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8C268A-D4F6-44C2-BC01-686C4743A2C7}" type="datetimeFigureOut">
              <a:rPr lang="en-NZ" smtClean="0"/>
              <a:t>10/10/2022</a:t>
            </a:fld>
            <a:endParaRPr lang="en-NZ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5D9BE02-D974-BC53-8B91-B526AE9DA9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055D99E-EFD9-23E4-B13B-66DD2E9D79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4E2B87-E75F-405C-AB34-A4B4FD74D183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39035186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356B9B-5190-D941-EB88-6E4D95CA19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7C03A35-D864-B65B-62FF-CE03CA91C74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Z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215D2A3-C846-8EDB-97EE-AFFEF6433C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8C268A-D4F6-44C2-BC01-686C4743A2C7}" type="datetimeFigureOut">
              <a:rPr lang="en-NZ" smtClean="0"/>
              <a:t>10/10/2022</a:t>
            </a:fld>
            <a:endParaRPr lang="en-NZ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9D2E47F-D799-168A-61A3-22A12F0361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5C37342-BEEF-38FA-EB0B-E8BC5B08F2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4E2B87-E75F-405C-AB34-A4B4FD74D183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5953288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82FBBDF-D90B-ADEB-9E1E-1B4D5A742B2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6F42ECC-BB84-CEC1-7E36-0A9922E82D6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Z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179A656-BD94-514C-B197-D5E40EB889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8C268A-D4F6-44C2-BC01-686C4743A2C7}" type="datetimeFigureOut">
              <a:rPr lang="en-NZ" smtClean="0"/>
              <a:t>10/10/2022</a:t>
            </a:fld>
            <a:endParaRPr lang="en-NZ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D4E5E9C-F833-A487-97B4-E42680889B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FDA0157-749E-D7C3-C857-49D9DCEE99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4E2B87-E75F-405C-AB34-A4B4FD74D183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30234576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83FFEF-71DD-A110-87A6-C5942BFBE3C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5D17007-A0D9-5011-FC81-BD386317994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Z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1A8A6EB-A020-EDBB-17FC-2BBC05CF50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8C268A-D4F6-44C2-BC01-686C4743A2C7}" type="datetimeFigureOut">
              <a:rPr lang="en-NZ" smtClean="0"/>
              <a:t>10/10/2022</a:t>
            </a:fld>
            <a:endParaRPr lang="en-NZ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1A07248-1636-5090-4831-316785DBDC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CE0B542-239B-22C0-7D4C-151DBD5891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4E2B87-E75F-405C-AB34-A4B4FD74D183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567528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CFB3D88-86F0-5CBF-B177-E3F6E7E82DD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764066F-4B81-221E-E4FF-7F9688598ED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3364293-5021-27A1-86B6-CBA9AB7F63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8C268A-D4F6-44C2-BC01-686C4743A2C7}" type="datetimeFigureOut">
              <a:rPr lang="en-NZ" smtClean="0"/>
              <a:t>10/10/2022</a:t>
            </a:fld>
            <a:endParaRPr lang="en-NZ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23B5E84-9DAB-D034-208D-95E0693DC3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51EF3D7-D47A-851B-768C-4FDD6A4B92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4E2B87-E75F-405C-AB34-A4B4FD74D183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7753388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59D778-7D9F-9E22-4FE1-A942687FFC0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966B721-1472-8987-EFAF-CC06D971338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Z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289918D-CC1A-E868-DD6F-09B171550C4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Z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46728F1-634F-3F8F-5BE6-7BE0F4136F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8C268A-D4F6-44C2-BC01-686C4743A2C7}" type="datetimeFigureOut">
              <a:rPr lang="en-NZ" smtClean="0"/>
              <a:t>10/10/2022</a:t>
            </a:fld>
            <a:endParaRPr lang="en-NZ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4CA6A75-157F-2F95-39C4-9B4AC849B5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52BCA7C-29EA-DCEC-AD01-B52B3D1ECD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4E2B87-E75F-405C-AB34-A4B4FD74D183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7304373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B84E6D-F488-0451-E20C-83EBA5E1276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7138C46-ADBD-331B-3D57-BC45B3BD550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96D1D05-BC89-C73E-A986-DE04E8C3481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Z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9D993B6-ECE7-AA67-27C1-868BE51ACB3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1F3F400-381A-BC6E-AC6D-6166D770BE3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Z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F5150C7-5E6D-2FEE-EBB9-876D230C89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8C268A-D4F6-44C2-BC01-686C4743A2C7}" type="datetimeFigureOut">
              <a:rPr lang="en-NZ" smtClean="0"/>
              <a:t>10/10/2022</a:t>
            </a:fld>
            <a:endParaRPr lang="en-NZ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A3E3526-0A6C-2B40-3011-20F9FAC312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EE5021B-A6E4-D584-2EA6-6F8DC94A31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4E2B87-E75F-405C-AB34-A4B4FD74D183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4421987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E267429-69E1-44D9-A735-4E10C6B6E09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E9B0627-7E0A-6503-217C-CEFDF13ACD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8C268A-D4F6-44C2-BC01-686C4743A2C7}" type="datetimeFigureOut">
              <a:rPr lang="en-NZ" smtClean="0"/>
              <a:t>10/10/2022</a:t>
            </a:fld>
            <a:endParaRPr lang="en-NZ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13A7DE9-B698-1270-921E-9ECAB1E085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FFD156B-BA6D-2EB5-16D5-D181E6837E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4E2B87-E75F-405C-AB34-A4B4FD74D183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6340279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AD26A51-4EF1-A8E5-0E38-0EDB5F2C75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8C268A-D4F6-44C2-BC01-686C4743A2C7}" type="datetimeFigureOut">
              <a:rPr lang="en-NZ" smtClean="0"/>
              <a:t>10/10/2022</a:t>
            </a:fld>
            <a:endParaRPr lang="en-NZ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A235893-4B11-6E25-FBB7-A384D7F05A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C405994-AD8F-367B-FE3C-A8A0E7169B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4E2B87-E75F-405C-AB34-A4B4FD74D183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3789961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7523140-5738-A8B6-4C4F-F84C1158E54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01DDE55-71ED-CCA2-1C6C-2BC740C11AE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Z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F1E1849-E2EA-9111-54DF-B088B555774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0B6A13D-D3A6-E3E5-A4A4-F30A0C7459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8C268A-D4F6-44C2-BC01-686C4743A2C7}" type="datetimeFigureOut">
              <a:rPr lang="en-NZ" smtClean="0"/>
              <a:t>10/10/2022</a:t>
            </a:fld>
            <a:endParaRPr lang="en-NZ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17B0F93-3257-5E6F-0298-C134536DB3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5F665E4-5BDA-73B7-641C-3CD831D459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4E2B87-E75F-405C-AB34-A4B4FD74D183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6466743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43C2EA-FCEA-3F53-3736-344BE68561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8D12D60-32D7-24E4-59A8-5587FF0C53A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NZ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D0EFF32-A17B-654F-2C31-D1D562EA6B4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8749857-3446-A510-079A-90E1ABA9A5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8C268A-D4F6-44C2-BC01-686C4743A2C7}" type="datetimeFigureOut">
              <a:rPr lang="en-NZ" smtClean="0"/>
              <a:t>10/10/2022</a:t>
            </a:fld>
            <a:endParaRPr lang="en-NZ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9ECBA23-4EBC-280F-991F-25C0CC4365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75642F1-B9A9-42E7-5594-8F1358B7B0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4E2B87-E75F-405C-AB34-A4B4FD74D183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2123422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A2C3AFE-C448-141C-D71F-0B3905FD85B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A474ED9-B7B5-D882-631A-4049FAAB967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Z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6F31586-307E-412C-FA65-AC8326A47AF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8C268A-D4F6-44C2-BC01-686C4743A2C7}" type="datetimeFigureOut">
              <a:rPr lang="en-NZ" smtClean="0"/>
              <a:t>10/10/2022</a:t>
            </a:fld>
            <a:endParaRPr lang="en-NZ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3352F04-2423-8FBE-9A49-E73BD0CF252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NZ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7873186-63C0-D74A-EBFB-847F2F82597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4E2B87-E75F-405C-AB34-A4B4FD74D183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7162578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A3560008-B184-49FE-AC51-44EB5C3C51F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2939" y="0"/>
            <a:ext cx="11099030" cy="527265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CD5F0DC7-8537-CBC2-4EE8-8C4035CD561C}"/>
              </a:ext>
            </a:extLst>
          </p:cNvPr>
          <p:cNvSpPr txBox="1"/>
          <p:nvPr/>
        </p:nvSpPr>
        <p:spPr>
          <a:xfrm>
            <a:off x="112939" y="5272650"/>
            <a:ext cx="12136211" cy="138499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spcBef>
                <a:spcPts val="600"/>
              </a:spcBef>
              <a:spcAft>
                <a:spcPts val="1200"/>
              </a:spcAft>
            </a:pPr>
            <a:r>
              <a:rPr lang="en-US" sz="14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S1.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Representation of the protein domains of disease resistant genes (RLKs, NBS-LRR) in the inflorescence primordium (IP) or ovary (OV) tissues and were associated with GO terms of ADP binding (GO:0043531) and ATP binding (GO:0005524). Transcriptome sequences were analyzed in silico by screening against the </a:t>
            </a:r>
            <a:r>
              <a:rPr lang="en-US" sz="14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olium perenne 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enome and the protein domains were based on PFAM (Protein Families) annotations. Under column ‘Gene’, in red are the genes whose expression was significantly different between the high-transmission (HT) and low-transmission (LT) genotypes only in the IP tissues, while in blue are genes only in the OV tissues. FC = fold change. DEGs with LT&gt;HT expression are indicated by a positive FC value while DEGs with LT&lt;HT expression are indicated by a negative FC value. CPM = counts per million.</a:t>
            </a:r>
            <a:endParaRPr lang="en-NZ" sz="14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272436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63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ei Zhang</dc:creator>
  <cp:lastModifiedBy>Wei Zhang</cp:lastModifiedBy>
  <cp:revision>1</cp:revision>
  <dcterms:created xsi:type="dcterms:W3CDTF">2022-10-10T10:40:57Z</dcterms:created>
  <dcterms:modified xsi:type="dcterms:W3CDTF">2022-10-10T10:46:41Z</dcterms:modified>
</cp:coreProperties>
</file>